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74913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118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3931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6377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5784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62460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7200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1037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9415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53527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3019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2256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752601" y="580907"/>
          <a:ext cx="5943597" cy="5746565"/>
        </p:xfrm>
        <a:graphic>
          <a:graphicData uri="http://schemas.openxmlformats.org/drawingml/2006/table">
            <a:tbl>
              <a:tblPr firstRow="1" firstCol="1" bandRow="1"/>
              <a:tblGrid>
                <a:gridCol w="752751"/>
                <a:gridCol w="1113446"/>
                <a:gridCol w="1176173"/>
                <a:gridCol w="297964"/>
                <a:gridCol w="752751"/>
                <a:gridCol w="752751"/>
                <a:gridCol w="1097761"/>
              </a:tblGrid>
              <a:tr h="4821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Name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g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C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st p-value among the 5 studies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Name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g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C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st p-value among the 5 studies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E2B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9761798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37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LD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5059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39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SN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9459208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14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BA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9510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89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TC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1975977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 X10-1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G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9065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99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orf4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8299134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 X10-0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XA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7105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5 X10-0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orf6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38513214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6 X10-0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R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6421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6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DS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15460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4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KK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6012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2 X10-0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CT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6903307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12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4638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13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PRV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1432567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1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VE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4637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12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ORS1C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6126059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3 X10-14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G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2304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2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PINB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2325584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14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5orf4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098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19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F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3922906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3 X10-1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P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6726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8 X10-1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ASE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4938559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3 X10-1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R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983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3772247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GDS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8013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9 X10-0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46A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4590336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2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A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5979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13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F1B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9536120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6 X10-0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D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4004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3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R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9415142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39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IT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3522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344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URP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7540680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36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11B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2030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16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MB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5184398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1 X10-1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J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1673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8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46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T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342278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52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HGAP1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0578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9 X10-1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BB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3413683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16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EG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0565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18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MOD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3319949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63 X10-0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DN2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5646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8 X10-0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IN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7573105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40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FRP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3298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4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BP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4646566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71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G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3236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1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GB2A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3238236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7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1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2831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38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D18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0680006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87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EL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04614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9 X10-0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L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9213098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11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D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0120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02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GN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9083804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17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X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9807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74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84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10013047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899772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95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O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03367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115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39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EM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64842093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119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P2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89311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376</a:t>
                      </a:r>
                    </a:p>
                  </a:txBody>
                  <a:tcPr marL="4540" marR="4540" marT="45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76400" y="196334"/>
            <a:ext cx="7543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able: Down-regulated genes</a:t>
            </a:r>
            <a:endParaRPr 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009646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5</Words>
  <Application>Microsoft Office PowerPoint</Application>
  <PresentationFormat>Widescreen</PresentationFormat>
  <Paragraphs>1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uglas Surwilo</dc:creator>
  <cp:lastModifiedBy>Douglas Surwilo</cp:lastModifiedBy>
  <cp:revision>1</cp:revision>
  <dcterms:created xsi:type="dcterms:W3CDTF">2015-12-11T19:32:28Z</dcterms:created>
  <dcterms:modified xsi:type="dcterms:W3CDTF">2015-12-11T19:32:50Z</dcterms:modified>
</cp:coreProperties>
</file>